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316" r:id="rId2"/>
  </p:sldIdLst>
  <p:sldSz cx="9601200" cy="12801600" type="A3"/>
  <p:notesSz cx="6858000" cy="9144000"/>
  <p:defaultTextStyle>
    <a:defPPr>
      <a:defRPr lang="ja-JP"/>
    </a:defPPr>
    <a:lvl1pPr marL="0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178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357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536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714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5892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070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249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428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oru Hanamura" initials="TH" lastIdx="4" clrIdx="0">
    <p:extLst>
      <p:ext uri="{19B8F6BF-5375-455C-9EA6-DF929625EA0E}">
        <p15:presenceInfo xmlns:p15="http://schemas.microsoft.com/office/powerpoint/2012/main" userId="Toru Hanamura" providerId="None"/>
      </p:ext>
    </p:extLst>
  </p:cmAuthor>
  <p:cmAuthor id="2" name="Richer, Jennifer" initials="RJ" lastIdx="6" clrIdx="1">
    <p:extLst>
      <p:ext uri="{19B8F6BF-5375-455C-9EA6-DF929625EA0E}">
        <p15:presenceInfo xmlns:p15="http://schemas.microsoft.com/office/powerpoint/2012/main" userId="Richer, Jennifer" providerId="None"/>
      </p:ext>
    </p:extLst>
  </p:cmAuthor>
  <p:cmAuthor id="3" name="花村 徹" initials="花村" lastIdx="2" clrIdx="2">
    <p:extLst>
      <p:ext uri="{19B8F6BF-5375-455C-9EA6-DF929625EA0E}">
        <p15:presenceInfo xmlns:p15="http://schemas.microsoft.com/office/powerpoint/2012/main" userId="713ce747a82cdf4e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108"/>
    <p:restoredTop sz="92978" autoAdjust="0"/>
  </p:normalViewPr>
  <p:slideViewPr>
    <p:cSldViewPr snapToGrid="0" snapToObjects="1">
      <p:cViewPr>
        <p:scale>
          <a:sx n="73" d="100"/>
          <a:sy n="73" d="100"/>
        </p:scale>
        <p:origin x="3048" y="-392"/>
      </p:cViewPr>
      <p:guideLst/>
    </p:cSldViewPr>
  </p:slideViewPr>
  <p:notesTextViewPr>
    <p:cViewPr>
      <p:scale>
        <a:sx n="95" d="100"/>
        <a:sy n="9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882A602-B26C-764C-9708-93A17553678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445F9A1-8BE5-B546-9533-9E59946FDE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70756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178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357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536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714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5892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070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249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428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ja-JP" altLang="en-US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72336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kumimoji="1"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kumimoji="1"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4E10FCE7-E561-CB41-B3FF-BD05849969D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429745"/>
              </p:ext>
            </p:extLst>
          </p:nvPr>
        </p:nvGraphicFramePr>
        <p:xfrm>
          <a:off x="728330" y="647331"/>
          <a:ext cx="8144539" cy="9981900"/>
        </p:xfrm>
        <a:graphic>
          <a:graphicData uri="http://schemas.openxmlformats.org/drawingml/2006/table">
            <a:tbl>
              <a:tblPr/>
              <a:tblGrid>
                <a:gridCol w="3154659">
                  <a:extLst>
                    <a:ext uri="{9D8B030D-6E8A-4147-A177-3AD203B41FA5}">
                      <a16:colId xmlns:a16="http://schemas.microsoft.com/office/drawing/2014/main" val="667223787"/>
                    </a:ext>
                  </a:extLst>
                </a:gridCol>
                <a:gridCol w="1199490">
                  <a:extLst>
                    <a:ext uri="{9D8B030D-6E8A-4147-A177-3AD203B41FA5}">
                      <a16:colId xmlns:a16="http://schemas.microsoft.com/office/drawing/2014/main" val="3631165594"/>
                    </a:ext>
                  </a:extLst>
                </a:gridCol>
                <a:gridCol w="2267037">
                  <a:extLst>
                    <a:ext uri="{9D8B030D-6E8A-4147-A177-3AD203B41FA5}">
                      <a16:colId xmlns:a16="http://schemas.microsoft.com/office/drawing/2014/main" val="2474504386"/>
                    </a:ext>
                  </a:extLst>
                </a:gridCol>
                <a:gridCol w="1523353">
                  <a:extLst>
                    <a:ext uri="{9D8B030D-6E8A-4147-A177-3AD203B41FA5}">
                      <a16:colId xmlns:a16="http://schemas.microsoft.com/office/drawing/2014/main" val="4156313752"/>
                    </a:ext>
                  </a:extLst>
                </a:gridCol>
              </a:tblGrid>
              <a:tr h="180481"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Supplementary table 5. Comparison of proliferative response to DHT between cell lines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60869913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ixed-effect analysis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40638038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Fixed effects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P value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　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　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15303377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Cell lines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&lt;0.0001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6177857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Dose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&lt;0.0001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63656734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cell lines x Dose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&lt;0.0001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　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　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81789307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ja-JP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　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　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　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　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29091668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jultipole comperison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35325990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Tukey's multiple comparisons test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ean Diff.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95.00% CI of diff.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Adjusted P Value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7374984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DA-MB-453 vs. HCC2185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3884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1493 to 0.6276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005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1530225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DA-MB-453 vs. BT-549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1936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4547 to 0.3418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054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94397710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DA-MB-453 vs. MDA-MB-468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2115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6852 to 0.3545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015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8889588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DA-MB-453 vs. BT-474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2882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1240 to 0.4523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002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25628221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DA-MB-453 vs. ZR-75-1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6921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05651 to 0.1949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6116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3269896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DA-MB-453 vs. SK-BR-3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1629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5976 to 0.2661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007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5337598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DA-MB-453 vs. MCF7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2118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5666 to 0.3669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035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95319224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DA-MB-453 vs. T-47D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1411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4070 to 0.1248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6466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8181027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HCC2185 vs. BT-549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1948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3668 to -0.02288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194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44819504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HCC2185 vs. MDA-MB-468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1769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3414 to -0.01249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293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42692257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HCC2185 vs. BT-474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1003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2418 to 0.04130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3064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06024708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HCC2185 vs. ZR-75-1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3192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5235 to -0.1150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008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21818400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HCC2185 vs. SK-BR-3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2255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3882 to -0.06283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03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13512681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HCC2185 vs. MCF7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1766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3346 to -0.01870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215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3254445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HCC2185 vs. T-47D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5295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9216 to -0.1375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041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35228142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BT-549 vs. MDA-MB-468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1789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04845 to 0.08424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9873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4512737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BT-549 vs. BT-474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9456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008838 to 0.1980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893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8039048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BT-549 vs. ZR-75-1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1244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2388 to -0.009985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27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37529157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BT-549 vs. SK-BR-3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03068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1129 to 0.05155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9197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1884227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BT-549 vs. MCF7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1819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08027 to 0.1166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999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33378270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BT-549 vs. T-47D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3347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6254 to -0.04398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173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68841141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DA-MB-468 vs. BT-474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7667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01349 to 0.1668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135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4395139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DA-MB-468 vs. ZR-75-1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1423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2476 to -0.03696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039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4691424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DA-MB-468 vs. SK-BR-3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04857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1273 to 0.03012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4722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54965901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DA-MB-468 vs. MCF7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002919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09811 to 0.09870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&gt;0.9999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93456005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DA-MB-468 vs. T-47D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3526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6621 to -0.04309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188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69386090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BT-474 vs. ZR-75-1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219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3434 to -0.09458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002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87558762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BT-474 vs. SK-BR-3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1252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2152 to -0.03531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028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9869669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BT-474 vs. MCF7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07638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1736 to 0.02082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1996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33836931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BT-474 vs. T-47D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4293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7452 to -0.1133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038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9084393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ZR-75-1 vs. SK-BR-3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9373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09612 to 0.1778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222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86550694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ZR-75-1 vs. MCF7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1426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4977 to 0.2354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01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89632634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ZR-75-1 vs. T-47D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2103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4569 to 0.03628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1314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9203448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SK-BR-3 vs. MCF7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4886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02708 to 0.1248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4208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76346481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SK-BR-3 vs. T-47D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304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5826 to -0.02542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265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96872919"/>
                  </a:ext>
                </a:extLst>
              </a:tr>
              <a:tr h="180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CF7 vs. T-47D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3529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6129 to -0.09288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039</a:t>
                      </a:r>
                    </a:p>
                  </a:txBody>
                  <a:tcPr marL="8460" marR="8460" marT="84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658088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27622105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ホワイ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919</TotalTime>
  <Words>447</Words>
  <Application>Microsoft Macintosh PowerPoint</Application>
  <PresentationFormat>A3 297x420 mm</PresentationFormat>
  <Paragraphs>16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Yu Gothic</vt:lpstr>
      <vt:lpstr>Arial</vt:lpstr>
      <vt:lpstr>Calibri</vt:lpstr>
      <vt:lpstr>Calibri Light</vt:lpstr>
      <vt:lpstr>ホワイト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>花村 徹</dc:creator>
  <cp:keywords/>
  <dc:description/>
  <cp:lastModifiedBy>花村 徹</cp:lastModifiedBy>
  <cp:revision>648</cp:revision>
  <cp:lastPrinted>2019-11-15T20:26:41Z</cp:lastPrinted>
  <dcterms:created xsi:type="dcterms:W3CDTF">2019-06-11T17:31:31Z</dcterms:created>
  <dcterms:modified xsi:type="dcterms:W3CDTF">2021-07-09T02:38:13Z</dcterms:modified>
  <cp:category/>
</cp:coreProperties>
</file>